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994" autoAdjust="0"/>
    <p:restoredTop sz="94676"/>
  </p:normalViewPr>
  <p:slideViewPr>
    <p:cSldViewPr snapToGrid="0">
      <p:cViewPr varScale="1">
        <p:scale>
          <a:sx n="64" d="100"/>
          <a:sy n="64" d="100"/>
        </p:scale>
        <p:origin x="63" y="2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74CD880-82D9-AADD-8EBE-A7B78D3EAC7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809F348-3FFB-A320-B6B0-A8F3DC1B5D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426DFEA-BF21-1CDF-7E6B-87FBA9C9EB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5924-C68C-41D6-8BF6-0AF97F2D3C88}" type="datetimeFigureOut">
              <a:rPr kumimoji="1" lang="ja-JP" altLang="en-US" smtClean="0"/>
              <a:t>2025/12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FE51F36-3A06-8DC7-BA2C-E9F36D6259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428AC73-1C04-0D09-85AC-A63F930546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BF72-767B-461F-BF3B-6AB6265E63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50178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F7EF0E-2ABC-B7BE-E17F-B5592EC26E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2CFAB84-BE36-F565-5027-A3A932F863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175F166-E5DC-E9EC-1093-D1747EDA9F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5924-C68C-41D6-8BF6-0AF97F2D3C88}" type="datetimeFigureOut">
              <a:rPr kumimoji="1" lang="ja-JP" altLang="en-US" smtClean="0"/>
              <a:t>2025/12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14FC9F4-6922-39CB-271D-42732C4EBB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25BE7C8-A033-E3BF-C6F1-316DAFEFE3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BF72-767B-461F-BF3B-6AB6265E63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463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C9A3698-C733-F3F6-A6E7-81C1506556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14DC50B-9798-1C59-647B-4243640D7E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E661382-1ADE-C8F1-835E-B27B91C08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5924-C68C-41D6-8BF6-0AF97F2D3C88}" type="datetimeFigureOut">
              <a:rPr kumimoji="1" lang="ja-JP" altLang="en-US" smtClean="0"/>
              <a:t>2025/12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344FEC3-EB36-945D-90A9-2928C3F9A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94AF5A0-6297-0C7F-34A3-5CEB3A1669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BF72-767B-461F-BF3B-6AB6265E63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2361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884073-C56A-D0E4-AB4A-0C2ABF2472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055AD48-1B0C-9805-EBB8-17638FEA9D6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6C6B3A7-8668-75AE-C487-B05B8C82A3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5924-C68C-41D6-8BF6-0AF97F2D3C88}" type="datetimeFigureOut">
              <a:rPr kumimoji="1" lang="ja-JP" altLang="en-US" smtClean="0"/>
              <a:t>2025/12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9A4421F-7F92-C4CE-E7FC-173E8F477B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D6D5D76-9213-3B91-FF87-097FC7E3C6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BF72-767B-461F-BF3B-6AB6265E63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2432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5B8B95-BFDC-1D09-44D3-2AD8877CAC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6BC4DDC-7C1C-C27D-2E2D-2D716E667B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C2DE1E5-A3AD-763D-CAFC-FB32994587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5924-C68C-41D6-8BF6-0AF97F2D3C88}" type="datetimeFigureOut">
              <a:rPr kumimoji="1" lang="ja-JP" altLang="en-US" smtClean="0"/>
              <a:t>2025/12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FFD65D2-0C92-4915-BF68-D304D5B5B7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473BD19-FB06-44FF-3A0F-11CEBE6BE7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BF72-767B-461F-BF3B-6AB6265E63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6671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287A57-0FBA-8E68-93EA-2CC0D6EDA5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CA9E8F1-76ED-B62E-8A42-302869540B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EF4C793-5939-8DC1-10FC-A2952F43FA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F36C96C-7E45-2599-E9E4-B98A2CF53B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5924-C68C-41D6-8BF6-0AF97F2D3C88}" type="datetimeFigureOut">
              <a:rPr kumimoji="1" lang="ja-JP" altLang="en-US" smtClean="0"/>
              <a:t>2025/12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B23129E-CF95-976B-4A43-9D5DC5A108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91350B8-D097-1148-3866-AFC2CC62F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BF72-767B-461F-BF3B-6AB6265E63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20092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7A8CC8-EA57-6CD0-6D53-3BCEE71FB5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08B075D-B961-2177-958A-B452326711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3821E7A-77BC-2FD0-BCCA-AA68116222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A773923-543A-0802-858E-C12D01E952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7AD8E19-4186-2A05-E005-9836426657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82828E6-794C-0DB2-78E1-6A2E40B754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5924-C68C-41D6-8BF6-0AF97F2D3C88}" type="datetimeFigureOut">
              <a:rPr kumimoji="1" lang="ja-JP" altLang="en-US" smtClean="0"/>
              <a:t>2025/12/2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2096DF2-1572-7E7B-7099-C2FAC74BD0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99FD189-3626-7F0C-5484-ED9784B24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BF72-767B-461F-BF3B-6AB6265E63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0330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1FBD20-F600-EB60-67C8-C4B2317970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4A98954-542A-5401-925B-CC8DD1589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5924-C68C-41D6-8BF6-0AF97F2D3C88}" type="datetimeFigureOut">
              <a:rPr kumimoji="1" lang="ja-JP" altLang="en-US" smtClean="0"/>
              <a:t>2025/12/2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3270747-617F-31B6-C829-A029A08B3D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889A9BB-211D-95EF-1D17-4BF268FE53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BF72-767B-461F-BF3B-6AB6265E63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86553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338FA08-29C1-949D-7FBC-D6A81CF76C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5924-C68C-41D6-8BF6-0AF97F2D3C88}" type="datetimeFigureOut">
              <a:rPr kumimoji="1" lang="ja-JP" altLang="en-US" smtClean="0"/>
              <a:t>2025/12/2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628442C-9253-DF28-FFBF-39C3981FE9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FEF74B3-0B01-9A16-B76C-D82EA908F6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BF72-767B-461F-BF3B-6AB6265E63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33941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2E16E9A-E895-5C75-552F-B90006098E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01228A7-B0FA-8B49-A527-47484B6903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E39E309-6E88-F531-DCB1-7B64EBDD85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DF2214F-B7F3-9CB7-D2B1-6B75A9CF0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5924-C68C-41D6-8BF6-0AF97F2D3C88}" type="datetimeFigureOut">
              <a:rPr kumimoji="1" lang="ja-JP" altLang="en-US" smtClean="0"/>
              <a:t>2025/12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BD83E68-BB13-9AB4-2FDF-18B4DE9062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972F177-A834-CDD9-B6D3-A7F2CB92F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BF72-767B-461F-BF3B-6AB6265E63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0884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3CA3171-0B3F-7626-610E-7B739B72E4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9C76CB7-FCB1-3895-2E88-A1C8E1147C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7D98F37-18CF-4872-2E83-5E6D35BEE2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DDBE3A2-18B0-74D6-F137-A3B385FAC7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5924-C68C-41D6-8BF6-0AF97F2D3C88}" type="datetimeFigureOut">
              <a:rPr kumimoji="1" lang="ja-JP" altLang="en-US" smtClean="0"/>
              <a:t>2025/12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9943513-996A-4B1A-BD03-8967FAC5E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D024F3C-4174-A855-901F-CE572FCE00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BF72-767B-461F-BF3B-6AB6265E63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3180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A4B29BE-36C0-8C9A-5398-5FFB93571F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4E3ABFF-0E81-C05D-3049-9EF455185F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429AD7C-5D6C-15DD-72EC-EF3836B133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6F5924-C68C-41D6-8BF6-0AF97F2D3C88}" type="datetimeFigureOut">
              <a:rPr kumimoji="1" lang="ja-JP" altLang="en-US" smtClean="0"/>
              <a:t>2025/12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1531864-4B04-8E1C-9DE9-F3A7B58D190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566D174-3FBD-2ED7-8CD6-682D1B1682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94BF72-767B-461F-BF3B-6AB6265E63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98908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グループ化 44">
            <a:extLst>
              <a:ext uri="{FF2B5EF4-FFF2-40B4-BE49-F238E27FC236}">
                <a16:creationId xmlns:a16="http://schemas.microsoft.com/office/drawing/2014/main" id="{DECA972D-D083-B425-3520-0884E276FC07}"/>
              </a:ext>
            </a:extLst>
          </p:cNvPr>
          <p:cNvGrpSpPr/>
          <p:nvPr/>
        </p:nvGrpSpPr>
        <p:grpSpPr>
          <a:xfrm>
            <a:off x="1145468" y="469382"/>
            <a:ext cx="10260031" cy="5919236"/>
            <a:chOff x="1276073" y="371290"/>
            <a:chExt cx="10260031" cy="5919236"/>
          </a:xfrm>
        </p:grpSpPr>
        <p:grpSp>
          <p:nvGrpSpPr>
            <p:cNvPr id="9" name="グループ化 8">
              <a:extLst>
                <a:ext uri="{FF2B5EF4-FFF2-40B4-BE49-F238E27FC236}">
                  <a16:creationId xmlns:a16="http://schemas.microsoft.com/office/drawing/2014/main" id="{7C3C92D2-B14E-4EC9-8F53-378D95AC8E20}"/>
                </a:ext>
              </a:extLst>
            </p:cNvPr>
            <p:cNvGrpSpPr/>
            <p:nvPr/>
          </p:nvGrpSpPr>
          <p:grpSpPr>
            <a:xfrm>
              <a:off x="1276073" y="371290"/>
              <a:ext cx="10260031" cy="5919236"/>
              <a:chOff x="-3694703" y="656172"/>
              <a:chExt cx="14284246" cy="6089790"/>
            </a:xfrm>
          </p:grpSpPr>
          <p:sp>
            <p:nvSpPr>
              <p:cNvPr id="10" name="正方形/長方形 9">
                <a:extLst>
                  <a:ext uri="{FF2B5EF4-FFF2-40B4-BE49-F238E27FC236}">
                    <a16:creationId xmlns:a16="http://schemas.microsoft.com/office/drawing/2014/main" id="{106E9F23-8EB0-BCB1-DB93-43BBABBE80CC}"/>
                  </a:ext>
                </a:extLst>
              </p:cNvPr>
              <p:cNvSpPr/>
              <p:nvPr/>
            </p:nvSpPr>
            <p:spPr>
              <a:xfrm>
                <a:off x="209630" y="1048728"/>
                <a:ext cx="6310735" cy="569723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游ゴシック" panose="020F0502020204030204"/>
                  <a:ea typeface="游ゴシック" panose="020B0400000000000000" pitchFamily="50" charset="-128"/>
                  <a:cs typeface="+mn-cs"/>
                </a:endParaRPr>
              </a:p>
            </p:txBody>
          </p:sp>
          <p:sp>
            <p:nvSpPr>
              <p:cNvPr id="11" name="正方形/長方形 10">
                <a:extLst>
                  <a:ext uri="{FF2B5EF4-FFF2-40B4-BE49-F238E27FC236}">
                    <a16:creationId xmlns:a16="http://schemas.microsoft.com/office/drawing/2014/main" id="{A87A2BAE-7543-F12A-0F89-97C889D8E318}"/>
                  </a:ext>
                </a:extLst>
              </p:cNvPr>
              <p:cNvSpPr/>
              <p:nvPr/>
            </p:nvSpPr>
            <p:spPr>
              <a:xfrm>
                <a:off x="-1367690" y="656172"/>
                <a:ext cx="5062877" cy="988536"/>
              </a:xfrm>
              <a:prstGeom prst="rect">
                <a:avLst/>
              </a:prstGeom>
              <a:solidFill>
                <a:schemeClr val="bg1"/>
              </a:solidFill>
              <a:ln w="28575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2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Hospitalized hip 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2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fracture patients enrolled 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2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(N=1,395)</a:t>
                </a:r>
                <a:endParaRPr kumimoji="1" lang="ja-JP" altLang="en-US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12" name="直線矢印コネクタ 11">
                <a:extLst>
                  <a:ext uri="{FF2B5EF4-FFF2-40B4-BE49-F238E27FC236}">
                    <a16:creationId xmlns:a16="http://schemas.microsoft.com/office/drawing/2014/main" id="{5F6CD6CE-FFF1-F310-1CCC-D58A8594027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88539" y="1643636"/>
                <a:ext cx="0" cy="1700961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直線コネクタ 12">
                <a:extLst>
                  <a:ext uri="{FF2B5EF4-FFF2-40B4-BE49-F238E27FC236}">
                    <a16:creationId xmlns:a16="http://schemas.microsoft.com/office/drawing/2014/main" id="{8F9CBD57-9859-74FD-050D-2E661343FA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367690" y="4491547"/>
                <a:ext cx="5246956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直線矢印コネクタ 13">
                <a:extLst>
                  <a:ext uri="{FF2B5EF4-FFF2-40B4-BE49-F238E27FC236}">
                    <a16:creationId xmlns:a16="http://schemas.microsoft.com/office/drawing/2014/main" id="{138864A7-DD27-0FF6-E6B4-D262941E761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11005" y="4194162"/>
                <a:ext cx="0" cy="297385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直線矢印コネクタ 14">
                <a:extLst>
                  <a:ext uri="{FF2B5EF4-FFF2-40B4-BE49-F238E27FC236}">
                    <a16:creationId xmlns:a16="http://schemas.microsoft.com/office/drawing/2014/main" id="{CA9B2F90-7936-2A4A-5FA6-55D040A0732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11005" y="2492710"/>
                <a:ext cx="1530501" cy="1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正方形/長方形 15">
                <a:extLst>
                  <a:ext uri="{FF2B5EF4-FFF2-40B4-BE49-F238E27FC236}">
                    <a16:creationId xmlns:a16="http://schemas.microsoft.com/office/drawing/2014/main" id="{B7A78E7D-3156-BAE1-D91E-458B3003E879}"/>
                  </a:ext>
                </a:extLst>
              </p:cNvPr>
              <p:cNvSpPr/>
              <p:nvPr/>
            </p:nvSpPr>
            <p:spPr>
              <a:xfrm>
                <a:off x="2741505" y="1760150"/>
                <a:ext cx="7848038" cy="1467933"/>
              </a:xfrm>
              <a:prstGeom prst="rect">
                <a:avLst/>
              </a:prstGeom>
              <a:solidFill>
                <a:schemeClr val="bg1"/>
              </a:solidFill>
              <a:ln w="28575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20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7" name="正方形/長方形 16">
                <a:extLst>
                  <a:ext uri="{FF2B5EF4-FFF2-40B4-BE49-F238E27FC236}">
                    <a16:creationId xmlns:a16="http://schemas.microsoft.com/office/drawing/2014/main" id="{4335E806-376E-1452-4413-A2CA7CC7DEEB}"/>
                  </a:ext>
                </a:extLst>
              </p:cNvPr>
              <p:cNvSpPr/>
              <p:nvPr/>
            </p:nvSpPr>
            <p:spPr>
              <a:xfrm>
                <a:off x="-1367690" y="3346160"/>
                <a:ext cx="5062877" cy="848002"/>
              </a:xfrm>
              <a:prstGeom prst="rect">
                <a:avLst/>
              </a:prstGeom>
              <a:solidFill>
                <a:schemeClr val="bg1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2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Patients remaining in analysis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2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(N=919)</a:t>
                </a:r>
              </a:p>
            </p:txBody>
          </p:sp>
          <p:sp>
            <p:nvSpPr>
              <p:cNvPr id="19" name="正方形/長方形 18">
                <a:extLst>
                  <a:ext uri="{FF2B5EF4-FFF2-40B4-BE49-F238E27FC236}">
                    <a16:creationId xmlns:a16="http://schemas.microsoft.com/office/drawing/2014/main" id="{23187DF6-8F85-4FE8-0B76-C2ACF5A6F12B}"/>
                  </a:ext>
                </a:extLst>
              </p:cNvPr>
              <p:cNvSpPr/>
              <p:nvPr/>
            </p:nvSpPr>
            <p:spPr>
              <a:xfrm>
                <a:off x="-3694703" y="4750017"/>
                <a:ext cx="4654026" cy="1117861"/>
              </a:xfrm>
              <a:prstGeom prst="rect">
                <a:avLst/>
              </a:prstGeom>
              <a:solidFill>
                <a:schemeClr val="bg1"/>
              </a:solidFill>
              <a:ln w="28575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2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Patients with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2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secondary hip fracture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2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(N=31)</a:t>
                </a:r>
                <a:endParaRPr kumimoji="1" lang="ja-JP" altLang="en-US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20" name="直線コネクタ 19">
                <a:extLst>
                  <a:ext uri="{FF2B5EF4-FFF2-40B4-BE49-F238E27FC236}">
                    <a16:creationId xmlns:a16="http://schemas.microsoft.com/office/drawing/2014/main" id="{A85DE6E2-DEF7-ACC7-21CC-EE86D8CD78A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367689" y="4486771"/>
                <a:ext cx="0" cy="27566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直線コネクタ 20">
                <a:extLst>
                  <a:ext uri="{FF2B5EF4-FFF2-40B4-BE49-F238E27FC236}">
                    <a16:creationId xmlns:a16="http://schemas.microsoft.com/office/drawing/2014/main" id="{847027F7-E133-9793-2729-140FE12A816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879266" y="4472646"/>
                <a:ext cx="1" cy="289791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正方形/長方形 21">
                <a:extLst>
                  <a:ext uri="{FF2B5EF4-FFF2-40B4-BE49-F238E27FC236}">
                    <a16:creationId xmlns:a16="http://schemas.microsoft.com/office/drawing/2014/main" id="{3D6C07AE-4C20-2844-A151-81F43B717FEF}"/>
                  </a:ext>
                </a:extLst>
              </p:cNvPr>
              <p:cNvSpPr/>
              <p:nvPr/>
            </p:nvSpPr>
            <p:spPr>
              <a:xfrm>
                <a:off x="1556698" y="4765274"/>
                <a:ext cx="4645135" cy="1117862"/>
              </a:xfrm>
              <a:prstGeom prst="rect">
                <a:avLst/>
              </a:prstGeom>
              <a:solidFill>
                <a:schemeClr val="bg1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2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Patients without 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2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secondary hip fracture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2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(N=888)</a:t>
                </a:r>
                <a:endParaRPr kumimoji="1" lang="ja-JP" altLang="en-US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512A773D-6289-7EB1-C52E-BA50D6242F16}"/>
                </a:ext>
              </a:extLst>
            </p:cNvPr>
            <p:cNvSpPr txBox="1"/>
            <p:nvPr/>
          </p:nvSpPr>
          <p:spPr>
            <a:xfrm>
              <a:off x="5899047" y="1453543"/>
              <a:ext cx="5518653" cy="13234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 Patients excluded: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ja-JP" altLang="en-US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・</a:t>
              </a: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History of contralateral hip fracture (N=172) </a:t>
              </a:r>
              <a:r>
                <a:rPr kumimoji="1" lang="ja-JP" altLang="en-US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　</a:t>
              </a:r>
              <a:endPara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ja-JP" altLang="en-US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・</a:t>
              </a: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Died within 1 year  (N=162)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ja-JP" altLang="en-US" sz="20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・</a:t>
              </a:r>
              <a:r>
                <a:rPr kumimoji="1" lang="en-US" altLang="ja-JP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Follow-up not possible (N=142)</a:t>
              </a:r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69FDD41-50A9-1508-8B50-B890C619E62A}"/>
              </a:ext>
            </a:extLst>
          </p:cNvPr>
          <p:cNvSpPr txBox="1"/>
          <p:nvPr/>
        </p:nvSpPr>
        <p:spPr>
          <a:xfrm>
            <a:off x="1067268" y="5893414"/>
            <a:ext cx="60950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kumimoji="1" lang="en-US" altLang="ja-JP" b="1">
                <a:latin typeface="Arial" panose="020B0604020202020204" pitchFamily="34" charset="0"/>
                <a:cs typeface="Arial" panose="020B0604020202020204" pitchFamily="34" charset="0"/>
              </a:rPr>
              <a:t>.S1</a:t>
            </a:r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52003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796FE946-496E-43C6-45B7-55D391EF63F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774" y="799398"/>
            <a:ext cx="5259203" cy="5259203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82468F0-BCCD-0D70-9332-AB39FFEC6305}"/>
              </a:ext>
            </a:extLst>
          </p:cNvPr>
          <p:cNvSpPr txBox="1"/>
          <p:nvPr/>
        </p:nvSpPr>
        <p:spPr>
          <a:xfrm>
            <a:off x="1145468" y="5994698"/>
            <a:ext cx="68058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ig.S2</a:t>
            </a:r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66236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6</TotalTime>
  <Words>79</Words>
  <Application>Microsoft Office PowerPoint</Application>
  <PresentationFormat>ワイド画面</PresentationFormat>
  <Paragraphs>17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柊 高田</dc:creator>
  <cp:lastModifiedBy>柊 高田</cp:lastModifiedBy>
  <cp:revision>14</cp:revision>
  <dcterms:created xsi:type="dcterms:W3CDTF">2025-02-14T07:15:14Z</dcterms:created>
  <dcterms:modified xsi:type="dcterms:W3CDTF">2025-12-26T06:46:42Z</dcterms:modified>
</cp:coreProperties>
</file>